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39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3B0F0B-D38C-4687-B850-FC7172C705B4}" type="datetimeFigureOut">
              <a:rPr lang="en-CA" smtClean="0"/>
              <a:t>2020-01-27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C64BB4-8161-4E0C-9F22-F40B1B80FFA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883080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7CB0B-48AB-412C-A159-9566AEE3D8DD}" type="datetimeFigureOut">
              <a:rPr lang="en-CA" smtClean="0"/>
              <a:t>2020-01-2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1F962-2653-457F-8556-C4A8E7E9AD6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89267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7CB0B-48AB-412C-A159-9566AEE3D8DD}" type="datetimeFigureOut">
              <a:rPr lang="en-CA" smtClean="0"/>
              <a:t>2020-01-2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1F962-2653-457F-8556-C4A8E7E9AD6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137893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7CB0B-48AB-412C-A159-9566AEE3D8DD}" type="datetimeFigureOut">
              <a:rPr lang="en-CA" smtClean="0"/>
              <a:t>2020-01-2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1F962-2653-457F-8556-C4A8E7E9AD6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56486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7CB0B-48AB-412C-A159-9566AEE3D8DD}" type="datetimeFigureOut">
              <a:rPr lang="en-CA" smtClean="0"/>
              <a:t>2020-01-2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1F962-2653-457F-8556-C4A8E7E9AD6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23434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7CB0B-48AB-412C-A159-9566AEE3D8DD}" type="datetimeFigureOut">
              <a:rPr lang="en-CA" smtClean="0"/>
              <a:t>2020-01-2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1F962-2653-457F-8556-C4A8E7E9AD6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156209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7CB0B-48AB-412C-A159-9566AEE3D8DD}" type="datetimeFigureOut">
              <a:rPr lang="en-CA" smtClean="0"/>
              <a:t>2020-01-2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1F962-2653-457F-8556-C4A8E7E9AD6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195289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7CB0B-48AB-412C-A159-9566AEE3D8DD}" type="datetimeFigureOut">
              <a:rPr lang="en-CA" smtClean="0"/>
              <a:t>2020-01-27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1F962-2653-457F-8556-C4A8E7E9AD6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853943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7CB0B-48AB-412C-A159-9566AEE3D8DD}" type="datetimeFigureOut">
              <a:rPr lang="en-CA" smtClean="0"/>
              <a:t>2020-01-27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1F962-2653-457F-8556-C4A8E7E9AD6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169715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7CB0B-48AB-412C-A159-9566AEE3D8DD}" type="datetimeFigureOut">
              <a:rPr lang="en-CA" smtClean="0"/>
              <a:t>2020-01-27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1F962-2653-457F-8556-C4A8E7E9AD6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66852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7CB0B-48AB-412C-A159-9566AEE3D8DD}" type="datetimeFigureOut">
              <a:rPr lang="en-CA" smtClean="0"/>
              <a:t>2020-01-2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1F962-2653-457F-8556-C4A8E7E9AD6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144705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7CB0B-48AB-412C-A159-9566AEE3D8DD}" type="datetimeFigureOut">
              <a:rPr lang="en-CA" smtClean="0"/>
              <a:t>2020-01-2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1F962-2653-457F-8556-C4A8E7E9AD6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838445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87CB0B-48AB-412C-A159-9566AEE3D8DD}" type="datetimeFigureOut">
              <a:rPr lang="en-CA" smtClean="0"/>
              <a:t>2020-01-2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11F962-2653-457F-8556-C4A8E7E9AD6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63575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DB19DB1-6DA4-4FC5-9C75-AF291171AA59}"/>
              </a:ext>
            </a:extLst>
          </p:cNvPr>
          <p:cNvSpPr txBox="1"/>
          <p:nvPr/>
        </p:nvSpPr>
        <p:spPr>
          <a:xfrm>
            <a:off x="245327" y="4761571"/>
            <a:ext cx="6612673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>
              <a:defRPr/>
            </a:pPr>
            <a:r>
              <a:rPr lang="en-CA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Both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uN2B and GluN2A contribute prominently to NMDAR responses at lamina II synapses.</a:t>
            </a:r>
          </a:p>
          <a:p>
            <a:pPr defTabSz="914400">
              <a:defRPr/>
            </a:pP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NMDAR charge transfer following application of 1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o25-6981 (red, n=13) or 10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CN-201 (green, n=14), with the baseline NMDAR charge transfer for the corresponding cells shown in the black bars to the left. Note the lack of difference between baseline charge transfer values for Ro25-6981- versus TCN-201-treated cells.</a:t>
            </a:r>
            <a:endParaRPr lang="en-CA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7E9F5790-AB42-4C21-A64C-6E223EB22AAE}"/>
              </a:ext>
            </a:extLst>
          </p:cNvPr>
          <p:cNvGrpSpPr/>
          <p:nvPr/>
        </p:nvGrpSpPr>
        <p:grpSpPr>
          <a:xfrm>
            <a:off x="985241" y="667088"/>
            <a:ext cx="4568225" cy="3400470"/>
            <a:chOff x="5653592" y="-62318"/>
            <a:chExt cx="4568225" cy="340047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2E74A95A-22C0-4549-BB38-CA6B4365BB7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120707" y="-62318"/>
              <a:ext cx="4101110" cy="3400470"/>
            </a:xfrm>
            <a:prstGeom prst="rect">
              <a:avLst/>
            </a:prstGeom>
          </p:spPr>
        </p:pic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DF6FE2A7-9B7C-4FEE-B5E1-A798D6C432DE}"/>
                </a:ext>
              </a:extLst>
            </p:cNvPr>
            <p:cNvGrpSpPr/>
            <p:nvPr/>
          </p:nvGrpSpPr>
          <p:grpSpPr>
            <a:xfrm>
              <a:off x="5653592" y="106892"/>
              <a:ext cx="4180598" cy="3153469"/>
              <a:chOff x="5670525" y="225423"/>
              <a:chExt cx="4180598" cy="3153469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24B80B18-6C86-439C-B2D2-40C732C9C117}"/>
                  </a:ext>
                </a:extLst>
              </p:cNvPr>
              <p:cNvGrpSpPr/>
              <p:nvPr/>
            </p:nvGrpSpPr>
            <p:grpSpPr>
              <a:xfrm>
                <a:off x="5670525" y="225423"/>
                <a:ext cx="4180598" cy="3153469"/>
                <a:chOff x="5670525" y="225423"/>
                <a:chExt cx="4180598" cy="3153469"/>
              </a:xfrm>
            </p:grpSpPr>
            <p:grpSp>
              <p:nvGrpSpPr>
                <p:cNvPr id="10" name="Group 9">
                  <a:extLst>
                    <a:ext uri="{FF2B5EF4-FFF2-40B4-BE49-F238E27FC236}">
                      <a16:creationId xmlns:a16="http://schemas.microsoft.com/office/drawing/2014/main" id="{AC8723C3-522A-4136-8722-7F7F789D4C7B}"/>
                    </a:ext>
                  </a:extLst>
                </p:cNvPr>
                <p:cNvGrpSpPr/>
                <p:nvPr/>
              </p:nvGrpSpPr>
              <p:grpSpPr>
                <a:xfrm>
                  <a:off x="5670525" y="225423"/>
                  <a:ext cx="4180598" cy="3153469"/>
                  <a:chOff x="5670525" y="225423"/>
                  <a:chExt cx="4180598" cy="3153469"/>
                </a:xfrm>
              </p:grpSpPr>
              <p:grpSp>
                <p:nvGrpSpPr>
                  <p:cNvPr id="12" name="Group 11">
                    <a:extLst>
                      <a:ext uri="{FF2B5EF4-FFF2-40B4-BE49-F238E27FC236}">
                        <a16:creationId xmlns:a16="http://schemas.microsoft.com/office/drawing/2014/main" id="{102041D6-F8FF-4A7F-9CF6-8295CAD5D587}"/>
                      </a:ext>
                    </a:extLst>
                  </p:cNvPr>
                  <p:cNvGrpSpPr/>
                  <p:nvPr/>
                </p:nvGrpSpPr>
                <p:grpSpPr>
                  <a:xfrm>
                    <a:off x="5670525" y="310551"/>
                    <a:ext cx="4180598" cy="3068341"/>
                    <a:chOff x="5940277" y="221161"/>
                    <a:chExt cx="4393390" cy="3068341"/>
                  </a:xfrm>
                </p:grpSpPr>
                <p:grpSp>
                  <p:nvGrpSpPr>
                    <p:cNvPr id="14" name="Group 13">
                      <a:extLst>
                        <a:ext uri="{FF2B5EF4-FFF2-40B4-BE49-F238E27FC236}">
                          <a16:creationId xmlns:a16="http://schemas.microsoft.com/office/drawing/2014/main" id="{D5EADDE7-F05F-4F3E-87DF-B4AB3A64636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940277" y="221161"/>
                      <a:ext cx="1416922" cy="2701346"/>
                      <a:chOff x="5940277" y="416205"/>
                      <a:chExt cx="1416922" cy="2867238"/>
                    </a:xfrm>
                  </p:grpSpPr>
                  <p:sp>
                    <p:nvSpPr>
                      <p:cNvPr id="20" name="TextBox 19">
                        <a:extLst>
                          <a:ext uri="{FF2B5EF4-FFF2-40B4-BE49-F238E27FC236}">
                            <a16:creationId xmlns:a16="http://schemas.microsoft.com/office/drawing/2014/main" id="{1E6ED5D5-EF8C-45B0-AB06-BF5DA469B0C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881786" y="2891430"/>
                        <a:ext cx="263937" cy="39201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0</a:t>
                        </a:r>
                      </a:p>
                    </p:txBody>
                  </p:sp>
                  <p:sp>
                    <p:nvSpPr>
                      <p:cNvPr id="21" name="TextBox 20">
                        <a:extLst>
                          <a:ext uri="{FF2B5EF4-FFF2-40B4-BE49-F238E27FC236}">
                            <a16:creationId xmlns:a16="http://schemas.microsoft.com/office/drawing/2014/main" id="{C14D0887-E514-462B-AC70-73298D20172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683703" y="2433568"/>
                        <a:ext cx="673496" cy="39201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.0</a:t>
                        </a:r>
                      </a:p>
                    </p:txBody>
                  </p:sp>
                  <p:sp>
                    <p:nvSpPr>
                      <p:cNvPr id="22" name="TextBox 21">
                        <a:extLst>
                          <a:ext uri="{FF2B5EF4-FFF2-40B4-BE49-F238E27FC236}">
                            <a16:creationId xmlns:a16="http://schemas.microsoft.com/office/drawing/2014/main" id="{840F5A76-44B0-4C15-922F-B1D4AA20E31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669692" y="1923258"/>
                        <a:ext cx="673496" cy="39201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2.0</a:t>
                        </a:r>
                      </a:p>
                    </p:txBody>
                  </p:sp>
                  <p:sp>
                    <p:nvSpPr>
                      <p:cNvPr id="23" name="TextBox 22">
                        <a:extLst>
                          <a:ext uri="{FF2B5EF4-FFF2-40B4-BE49-F238E27FC236}">
                            <a16:creationId xmlns:a16="http://schemas.microsoft.com/office/drawing/2014/main" id="{4572754F-7EF2-447A-9CD0-F9E370C573F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669692" y="1394055"/>
                        <a:ext cx="629100" cy="39201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3.0</a:t>
                        </a:r>
                      </a:p>
                    </p:txBody>
                  </p:sp>
                  <p:sp>
                    <p:nvSpPr>
                      <p:cNvPr id="24" name="TextBox 23">
                        <a:extLst>
                          <a:ext uri="{FF2B5EF4-FFF2-40B4-BE49-F238E27FC236}">
                            <a16:creationId xmlns:a16="http://schemas.microsoft.com/office/drawing/2014/main" id="{7D2623D6-EC82-4F8D-A6AB-B3546B907E20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4951247" y="1405235"/>
                        <a:ext cx="2721978" cy="74391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20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 NMDAR Charge Transfer (</a:t>
                        </a:r>
                        <a:r>
                          <a:rPr lang="en-US" sz="2000" b="1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C</a:t>
                        </a:r>
                        <a:r>
                          <a:rPr lang="en-US" sz="20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)</a:t>
                        </a:r>
                      </a:p>
                    </p:txBody>
                  </p:sp>
                </p:grpSp>
                <p:grpSp>
                  <p:nvGrpSpPr>
                    <p:cNvPr id="15" name="Group 14">
                      <a:extLst>
                        <a:ext uri="{FF2B5EF4-FFF2-40B4-BE49-F238E27FC236}">
                          <a16:creationId xmlns:a16="http://schemas.microsoft.com/office/drawing/2014/main" id="{B12BAAF5-BA03-4BB0-BB6C-5C7CDDFF99A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722263" y="2840040"/>
                      <a:ext cx="3611404" cy="449462"/>
                      <a:chOff x="6722263" y="2840040"/>
                      <a:chExt cx="3611404" cy="449462"/>
                    </a:xfrm>
                  </p:grpSpPr>
                  <p:sp>
                    <p:nvSpPr>
                      <p:cNvPr id="16" name="TextBox 15">
                        <a:extLst>
                          <a:ext uri="{FF2B5EF4-FFF2-40B4-BE49-F238E27FC236}">
                            <a16:creationId xmlns:a16="http://schemas.microsoft.com/office/drawing/2014/main" id="{9359CA86-4DFE-483D-9279-20CE0C12AE71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20096384">
                        <a:off x="8836030" y="2840040"/>
                        <a:ext cx="1497637" cy="33855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6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TCN-201</a:t>
                        </a:r>
                      </a:p>
                    </p:txBody>
                  </p:sp>
                  <p:sp>
                    <p:nvSpPr>
                      <p:cNvPr id="17" name="TextBox 16">
                        <a:extLst>
                          <a:ext uri="{FF2B5EF4-FFF2-40B4-BE49-F238E27FC236}">
                            <a16:creationId xmlns:a16="http://schemas.microsoft.com/office/drawing/2014/main" id="{766CC2B5-502F-4E75-835E-E53EB2654D29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20176537">
                        <a:off x="7174585" y="2950948"/>
                        <a:ext cx="1507857" cy="33855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6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o25-6981</a:t>
                        </a:r>
                      </a:p>
                    </p:txBody>
                  </p:sp>
                  <p:sp>
                    <p:nvSpPr>
                      <p:cNvPr id="18" name="TextBox 17">
                        <a:extLst>
                          <a:ext uri="{FF2B5EF4-FFF2-40B4-BE49-F238E27FC236}">
                            <a16:creationId xmlns:a16="http://schemas.microsoft.com/office/drawing/2014/main" id="{F40BC0D1-EBEC-42D6-851B-68CD68430143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942890">
                        <a:off x="8203023" y="2947747"/>
                        <a:ext cx="1039927" cy="33855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6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ontrol</a:t>
                        </a:r>
                      </a:p>
                    </p:txBody>
                  </p:sp>
                  <p:sp>
                    <p:nvSpPr>
                      <p:cNvPr id="19" name="TextBox 18">
                        <a:extLst>
                          <a:ext uri="{FF2B5EF4-FFF2-40B4-BE49-F238E27FC236}">
                            <a16:creationId xmlns:a16="http://schemas.microsoft.com/office/drawing/2014/main" id="{EDF07D3F-6F58-47CC-9DB4-9331438C5CF4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20271206">
                        <a:off x="6722263" y="2905164"/>
                        <a:ext cx="1039927" cy="33855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6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ontrol</a:t>
                        </a:r>
                      </a:p>
                    </p:txBody>
                  </p:sp>
                </p:grpSp>
              </p:grpSp>
              <p:sp>
                <p:nvSpPr>
                  <p:cNvPr id="13" name="TextBox 12">
                    <a:extLst>
                      <a:ext uri="{FF2B5EF4-FFF2-40B4-BE49-F238E27FC236}">
                        <a16:creationId xmlns:a16="http://schemas.microsoft.com/office/drawing/2014/main" id="{8999234B-9E82-4AAC-A1EB-E9D9CA1AF532}"/>
                      </a:ext>
                    </a:extLst>
                  </p:cNvPr>
                  <p:cNvSpPr txBox="1"/>
                  <p:nvPr/>
                </p:nvSpPr>
                <p:spPr>
                  <a:xfrm>
                    <a:off x="6319876" y="225423"/>
                    <a:ext cx="640876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.0</a:t>
                    </a:r>
                  </a:p>
                </p:txBody>
              </p:sp>
            </p:grp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40441EE8-7C5E-4FD0-A310-34564ED6A9CC}"/>
                    </a:ext>
                  </a:extLst>
                </p:cNvPr>
                <p:cNvSpPr txBox="1"/>
                <p:nvPr/>
              </p:nvSpPr>
              <p:spPr>
                <a:xfrm>
                  <a:off x="6369109" y="742923"/>
                  <a:ext cx="64087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.0</a:t>
                  </a:r>
                </a:p>
              </p:txBody>
            </p:sp>
          </p:grp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B1F8337B-7F68-4832-8127-C817D22AD5FA}"/>
                  </a:ext>
                </a:extLst>
              </p:cNvPr>
              <p:cNvSpPr txBox="1"/>
              <p:nvPr/>
            </p:nvSpPr>
            <p:spPr>
              <a:xfrm>
                <a:off x="9041277" y="902773"/>
                <a:ext cx="29512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FD902372-7C05-43B3-AFBE-6B6BB806109B}"/>
                  </a:ext>
                </a:extLst>
              </p:cNvPr>
              <p:cNvSpPr txBox="1"/>
              <p:nvPr/>
            </p:nvSpPr>
            <p:spPr>
              <a:xfrm>
                <a:off x="7658719" y="1476962"/>
                <a:ext cx="29512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4703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03</TotalTime>
  <Words>100</Words>
  <Application>Microsoft Office PowerPoint</Application>
  <PresentationFormat>Letter Paper (8.5x11 in)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Hildebrand</dc:creator>
  <cp:lastModifiedBy>Michael Hildebrand</cp:lastModifiedBy>
  <cp:revision>22</cp:revision>
  <dcterms:created xsi:type="dcterms:W3CDTF">2019-11-08T12:50:48Z</dcterms:created>
  <dcterms:modified xsi:type="dcterms:W3CDTF">2020-01-28T03:38:35Z</dcterms:modified>
</cp:coreProperties>
</file>